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9"/>
    <p:restoredTop sz="94658"/>
  </p:normalViewPr>
  <p:slideViewPr>
    <p:cSldViewPr snapToGrid="0">
      <p:cViewPr varScale="1">
        <p:scale>
          <a:sx n="120" d="100"/>
          <a:sy n="120" d="100"/>
        </p:scale>
        <p:origin x="8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3CE211-FBF5-9ABC-F60A-DCE9440F10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676C50-2C96-28B7-60F8-CF52B284DB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CEDDD-15EF-9133-A643-3065D837F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F406E4-5717-2ED6-8219-D9C6739B3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F50753-CA83-C5F6-0508-BAD86699D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32474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D4AAC-B4AD-68E4-A11A-54646D959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C518C0-BE39-4E45-68C7-04665916FF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37FB0-7B8E-4934-8A14-21FD0415A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08FDE8-C486-2BEC-86F4-4DC6F1634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999575-6036-52A6-2171-25FAB6A3E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93143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7D19F2-6C97-189D-0BDA-5391C8CA0E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FF9A5D-F0BE-0629-A002-07691FCFBD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3F2CFB-BA99-2695-4050-9D4430FAE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EA97C0-2380-075F-8E5B-8F5DB9D9C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258CFF-7FF2-B184-91DD-CA4BE2547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927709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BDEB6-1332-2069-75B3-A2F916E60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DB7158-0119-4544-A6EE-4633776AFF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4D932F-65A5-2C3A-1E65-B7A8FC85B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513AFB-D4BB-7F1F-D1B3-60850ABB2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663FD-6804-C3A0-0136-ACFDCB417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43448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73627-5BBE-6C82-642C-D0E4AD0AA3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AFAC2F-BAE4-262C-A35C-2F59A1271C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052124-5420-C473-4C7B-875AE01DC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8CB58-2724-2C64-BE44-8BA493A54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5595AF-3851-5B13-AAB3-64B88E046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426515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4FE3C0-97A3-14F5-C6A9-6088BB35A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562B4D-EE7A-87E7-6A7A-0E39A1C9A4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4D16D6-6083-5843-088F-06FE323CFF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3CA2FC-5D0D-0E27-4017-3F963138F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6C9C01-A51A-1BBC-A708-3A84060F9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75BE30-3557-BC8D-618F-38FB9DEFB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793456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A1801-C57B-F606-B4BD-5259BE9A4D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CFB059-3547-9A4F-9B91-0E12C96327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B4F152-8D2A-619D-5FCB-15988E895E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B37D43-3C5C-8410-F557-6AE89A10E5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231819-3188-EFA7-C217-CF793DFF9B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A36CC5-C72E-8DB4-8CDB-D48523FD7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0635C7-B783-599F-5446-0D87861ED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C56280-6428-27C9-B7F4-C1393103F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40817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7E471-FE11-9B17-371E-D8B83A3848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7433C6-3A07-6965-A98C-0B57A52B1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146B5A-E14F-1014-226F-FD3C4BAAF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FEDC32-2062-9F00-267A-77EB30DE0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59333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3BA64F-75B5-A139-A2C5-B696E56EF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7A2C8D-2714-307D-D923-174BC90CD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1F051A-A3E1-35C0-F188-1B2E43E7F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95028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DAB8A-4C52-2CE8-EACA-D525B8D8D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6AC81A-2A79-E1DD-2E12-44EE639BF8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D808E1-E0B2-D148-1ADA-644B46D00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D3CB54-753C-72E8-7BFD-BBC0BD7E2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19CE4A-2D69-60F4-15FB-097B86D28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989664-75C4-020C-25FE-7B8369E79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99054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D6DA5-5E0E-2DC4-B6DB-21F4E61BB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004769-98C5-02FE-E0AF-A640C73047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C06552-A4B8-FBE9-D96A-90AED5D14F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14E7C9-0EE6-E25D-E051-04202353F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D1681F-FC6D-E2A2-97BA-AB57EC4EF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EEE724-C33D-3FA4-0C4E-F1445DBF3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137772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F839D6-50E7-3E25-4657-3989B5EE3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D6EACE-BAB3-76DC-3DFA-BC3F92B003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88E864-A171-E120-9FCC-AE13063627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498FF9-9172-6543-931C-A05C9686F6B9}" type="datetimeFigureOut">
              <a:rPr lang="en-NL" smtClean="0"/>
              <a:t>03/04/2026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5EA751-DA73-1A14-5F0A-34EB164D59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93BD27-7ACC-D342-A2B8-F323EDE81F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6035D2-FEC2-8147-8AC6-BDDEF6B6D1E0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84742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244CA35-F994-0D65-AA2F-4977E4487433}"/>
              </a:ext>
            </a:extLst>
          </p:cNvPr>
          <p:cNvCxnSpPr>
            <a:cxnSpLocks/>
          </p:cNvCxnSpPr>
          <p:nvPr/>
        </p:nvCxnSpPr>
        <p:spPr>
          <a:xfrm>
            <a:off x="533955" y="1417249"/>
            <a:ext cx="11171644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1F19AA5-84FB-A468-FAAB-55836488BA2C}"/>
              </a:ext>
            </a:extLst>
          </p:cNvPr>
          <p:cNvSpPr txBox="1"/>
          <p:nvPr/>
        </p:nvSpPr>
        <p:spPr>
          <a:xfrm>
            <a:off x="502057" y="517640"/>
            <a:ext cx="134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2013 - 201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D04598-5607-1D4D-D567-09C362380B0D}"/>
              </a:ext>
            </a:extLst>
          </p:cNvPr>
          <p:cNvSpPr txBox="1"/>
          <p:nvPr/>
        </p:nvSpPr>
        <p:spPr>
          <a:xfrm>
            <a:off x="2173376" y="506106"/>
            <a:ext cx="1132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201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40B5E0-C6FA-84DC-37C2-B4A2304B4B5B}"/>
              </a:ext>
            </a:extLst>
          </p:cNvPr>
          <p:cNvSpPr txBox="1"/>
          <p:nvPr/>
        </p:nvSpPr>
        <p:spPr>
          <a:xfrm>
            <a:off x="3337452" y="520904"/>
            <a:ext cx="100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201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6E06BC-3A3A-AD3A-2C3C-55D58C4378A6}"/>
              </a:ext>
            </a:extLst>
          </p:cNvPr>
          <p:cNvSpPr txBox="1"/>
          <p:nvPr/>
        </p:nvSpPr>
        <p:spPr>
          <a:xfrm>
            <a:off x="487441" y="1533066"/>
            <a:ext cx="1601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rom 77 items</a:t>
            </a:r>
            <a:endParaRPr lang="en-NL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50C58D-9B77-8C6D-4C9C-B35F8D5A4DC0}"/>
              </a:ext>
            </a:extLst>
          </p:cNvPr>
          <p:cNvSpPr txBox="1"/>
          <p:nvPr/>
        </p:nvSpPr>
        <p:spPr>
          <a:xfrm>
            <a:off x="533955" y="969359"/>
            <a:ext cx="1365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s </a:t>
            </a:r>
            <a:r>
              <a:rPr lang="en-NL" dirty="0"/>
              <a:t>0.1 to 1.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14578B0-BFE8-4DAA-9E14-74F767EA20E7}"/>
              </a:ext>
            </a:extLst>
          </p:cNvPr>
          <p:cNvSpPr txBox="1"/>
          <p:nvPr/>
        </p:nvSpPr>
        <p:spPr>
          <a:xfrm>
            <a:off x="2173376" y="958877"/>
            <a:ext cx="100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2.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4178E0-7495-C292-484B-8429C34F1177}"/>
              </a:ext>
            </a:extLst>
          </p:cNvPr>
          <p:cNvSpPr txBox="1"/>
          <p:nvPr/>
        </p:nvSpPr>
        <p:spPr>
          <a:xfrm>
            <a:off x="3357702" y="964993"/>
            <a:ext cx="818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123E5F-B0E6-1E19-6CF4-48C9B1884DA7}"/>
              </a:ext>
            </a:extLst>
          </p:cNvPr>
          <p:cNvSpPr txBox="1"/>
          <p:nvPr/>
        </p:nvSpPr>
        <p:spPr>
          <a:xfrm>
            <a:off x="2173376" y="1533066"/>
            <a:ext cx="540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8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78C8151-C488-C451-31B6-9ED64CD5D101}"/>
              </a:ext>
            </a:extLst>
          </p:cNvPr>
          <p:cNvSpPr txBox="1"/>
          <p:nvPr/>
        </p:nvSpPr>
        <p:spPr>
          <a:xfrm>
            <a:off x="3350334" y="1527916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8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BBFD060-6128-230D-85DF-2BD39B05FA5A}"/>
              </a:ext>
            </a:extLst>
          </p:cNvPr>
          <p:cNvSpPr txBox="1"/>
          <p:nvPr/>
        </p:nvSpPr>
        <p:spPr>
          <a:xfrm>
            <a:off x="4288910" y="151444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8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2449264-219B-DC70-D0A4-5AEB762C29CD}"/>
              </a:ext>
            </a:extLst>
          </p:cNvPr>
          <p:cNvSpPr txBox="1"/>
          <p:nvPr/>
        </p:nvSpPr>
        <p:spPr>
          <a:xfrm>
            <a:off x="4321768" y="968828"/>
            <a:ext cx="100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BC59B52-9F34-D62C-29FF-53F2566DDE7A}"/>
              </a:ext>
            </a:extLst>
          </p:cNvPr>
          <p:cNvSpPr txBox="1"/>
          <p:nvPr/>
        </p:nvSpPr>
        <p:spPr>
          <a:xfrm>
            <a:off x="5239959" y="975244"/>
            <a:ext cx="1116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93D64B-68A1-F0EA-7598-35CC98CF2B78}"/>
              </a:ext>
            </a:extLst>
          </p:cNvPr>
          <p:cNvSpPr txBox="1"/>
          <p:nvPr/>
        </p:nvSpPr>
        <p:spPr>
          <a:xfrm>
            <a:off x="5249109" y="151444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9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06D0CDA-C958-F98F-F9F4-12303C46854E}"/>
              </a:ext>
            </a:extLst>
          </p:cNvPr>
          <p:cNvSpPr txBox="1"/>
          <p:nvPr/>
        </p:nvSpPr>
        <p:spPr>
          <a:xfrm>
            <a:off x="6291881" y="971045"/>
            <a:ext cx="100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54BBEB-3DE5-1812-20BC-E52E7A9A86FC}"/>
              </a:ext>
            </a:extLst>
          </p:cNvPr>
          <p:cNvSpPr txBox="1"/>
          <p:nvPr/>
        </p:nvSpPr>
        <p:spPr>
          <a:xfrm>
            <a:off x="6318228" y="1512742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9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6B0E4EB-92C8-A205-C4D4-AB98B3371B94}"/>
              </a:ext>
            </a:extLst>
          </p:cNvPr>
          <p:cNvSpPr txBox="1"/>
          <p:nvPr/>
        </p:nvSpPr>
        <p:spPr>
          <a:xfrm>
            <a:off x="7306528" y="966029"/>
            <a:ext cx="818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621FED7-27DA-DE81-6895-DA2E73A66A54}"/>
              </a:ext>
            </a:extLst>
          </p:cNvPr>
          <p:cNvSpPr txBox="1"/>
          <p:nvPr/>
        </p:nvSpPr>
        <p:spPr>
          <a:xfrm>
            <a:off x="7324672" y="1504406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9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2AED03C-B757-95FC-B40F-F585EC4AEEC3}"/>
              </a:ext>
            </a:extLst>
          </p:cNvPr>
          <p:cNvSpPr txBox="1"/>
          <p:nvPr/>
        </p:nvSpPr>
        <p:spPr>
          <a:xfrm>
            <a:off x="8279401" y="978318"/>
            <a:ext cx="866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B66FB3C-CB83-BD15-377D-9D6B6F62C8F6}"/>
              </a:ext>
            </a:extLst>
          </p:cNvPr>
          <p:cNvSpPr txBox="1"/>
          <p:nvPr/>
        </p:nvSpPr>
        <p:spPr>
          <a:xfrm>
            <a:off x="8298094" y="1508397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95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94561FDF-FF67-7932-DE1B-8C81897DB11F}"/>
              </a:ext>
            </a:extLst>
          </p:cNvPr>
          <p:cNvCxnSpPr>
            <a:cxnSpLocks/>
          </p:cNvCxnSpPr>
          <p:nvPr/>
        </p:nvCxnSpPr>
        <p:spPr>
          <a:xfrm>
            <a:off x="533955" y="898986"/>
            <a:ext cx="111807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CFA8E516-5B46-C665-B04B-652987673AD3}"/>
              </a:ext>
            </a:extLst>
          </p:cNvPr>
          <p:cNvSpPr txBox="1"/>
          <p:nvPr/>
        </p:nvSpPr>
        <p:spPr>
          <a:xfrm>
            <a:off x="10416766" y="974966"/>
            <a:ext cx="866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AN</a:t>
            </a:r>
            <a:endParaRPr lang="en-NL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EAD0D9-AFD6-4F85-2630-6A0FB9C63858}"/>
              </a:ext>
            </a:extLst>
          </p:cNvPr>
          <p:cNvSpPr txBox="1"/>
          <p:nvPr/>
        </p:nvSpPr>
        <p:spPr>
          <a:xfrm>
            <a:off x="10420375" y="1501167"/>
            <a:ext cx="12852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o </a:t>
            </a:r>
            <a:r>
              <a:rPr lang="en-NL" dirty="0"/>
              <a:t>93 item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FF7EE25-10A1-ECA5-D101-3A5C6F109E92}"/>
              </a:ext>
            </a:extLst>
          </p:cNvPr>
          <p:cNvSpPr txBox="1"/>
          <p:nvPr/>
        </p:nvSpPr>
        <p:spPr>
          <a:xfrm>
            <a:off x="2168880" y="2390910"/>
            <a:ext cx="6557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hree items have been added.</a:t>
            </a:r>
          </a:p>
          <a:p>
            <a:r>
              <a:rPr lang="en-GB" sz="900" dirty="0"/>
              <a:t>Item ‘Guiding and supporting new colleagues and trainees’, minor and major adjustments at all levels.</a:t>
            </a:r>
            <a:endParaRPr lang="en-NL" sz="9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B648FBC-1681-47C5-0B15-38027F7EB1A4}"/>
              </a:ext>
            </a:extLst>
          </p:cNvPr>
          <p:cNvSpPr txBox="1"/>
          <p:nvPr/>
        </p:nvSpPr>
        <p:spPr>
          <a:xfrm>
            <a:off x="3343007" y="2742319"/>
            <a:ext cx="538320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Six items have been added.</a:t>
            </a:r>
          </a:p>
          <a:p>
            <a:r>
              <a:rPr lang="en-GB" sz="900" dirty="0"/>
              <a:t>Item ‘Listening skills’ with minor adjustments to 2 answers at beginner and expert levels.</a:t>
            </a:r>
          </a:p>
          <a:p>
            <a:r>
              <a:rPr lang="en-GB" sz="900" dirty="0"/>
              <a:t>Item ‘Guiding and supporting new colleagues and trainees’ with minor adjustments at the beginner level. </a:t>
            </a:r>
            <a:endParaRPr lang="en-NL" sz="9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3F46D42-5202-7DB1-BD5F-CD7B2D51E471}"/>
              </a:ext>
            </a:extLst>
          </p:cNvPr>
          <p:cNvSpPr txBox="1"/>
          <p:nvPr/>
        </p:nvSpPr>
        <p:spPr>
          <a:xfrm>
            <a:off x="6398036" y="4038231"/>
            <a:ext cx="443215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Item ‘Guiding and supporting new colleagues and trainees’ involves minor adjustments for beginner and competent levels, and major adjustments for proficient and expert levels. </a:t>
            </a:r>
            <a:endParaRPr lang="en-NL" sz="9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734174D-7B7E-B586-B93C-8408BC4596D3}"/>
              </a:ext>
            </a:extLst>
          </p:cNvPr>
          <p:cNvSpPr txBox="1"/>
          <p:nvPr/>
        </p:nvSpPr>
        <p:spPr>
          <a:xfrm>
            <a:off x="5277174" y="3398981"/>
            <a:ext cx="6442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One item was added.</a:t>
            </a:r>
          </a:p>
          <a:p>
            <a:r>
              <a:rPr lang="en-GB" sz="900" dirty="0"/>
              <a:t>Item ‘Peer consultation meetings’ received a minor label adjustment -&gt; removal of 'structured.’</a:t>
            </a:r>
          </a:p>
          <a:p>
            <a:r>
              <a:rPr lang="en-GB" sz="900" dirty="0"/>
              <a:t>Item ‘Inter-/multidisciplinary meetings’ received a minor label adjustment -&gt; removal of 'structured.’</a:t>
            </a:r>
          </a:p>
          <a:p>
            <a:r>
              <a:rPr lang="en-GB" sz="900" dirty="0"/>
              <a:t>Item ‘Guiding and supporting new colleagues and trainees’ received a minor adjustment at the beginner and competent levels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D61522C-1491-0827-11E7-6A603BC815B7}"/>
              </a:ext>
            </a:extLst>
          </p:cNvPr>
          <p:cNvSpPr txBox="1"/>
          <p:nvPr/>
        </p:nvSpPr>
        <p:spPr>
          <a:xfrm>
            <a:off x="9324587" y="4838796"/>
            <a:ext cx="1712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One item was added: ‘Nursing diagnoses,' with minor adjustments at the proficient and expert levels.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01D504F-A8CA-D7CD-19F8-5D0AA9C04FA1}"/>
              </a:ext>
            </a:extLst>
          </p:cNvPr>
          <p:cNvSpPr txBox="1"/>
          <p:nvPr/>
        </p:nvSpPr>
        <p:spPr>
          <a:xfrm>
            <a:off x="9289969" y="978318"/>
            <a:ext cx="591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3.6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7AD9EEB-5D5D-F631-9FA2-67C98B7F3E28}"/>
              </a:ext>
            </a:extLst>
          </p:cNvPr>
          <p:cNvSpPr txBox="1"/>
          <p:nvPr/>
        </p:nvSpPr>
        <p:spPr>
          <a:xfrm>
            <a:off x="10558574" y="5313219"/>
            <a:ext cx="159561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he items ‘Identifying overburdened informal carers,’ ‘Psychogeriatric diseases, disorders, and impairments,’ and ‘Sharing knowledge via social media’ have been removed.</a:t>
            </a:r>
            <a:endParaRPr lang="en-NL" sz="9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C264DA2-BC26-ACF9-6603-CB09B9E6CE5F}"/>
              </a:ext>
            </a:extLst>
          </p:cNvPr>
          <p:cNvSpPr txBox="1"/>
          <p:nvPr/>
        </p:nvSpPr>
        <p:spPr>
          <a:xfrm>
            <a:off x="4303491" y="3237744"/>
            <a:ext cx="16754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sz="900" dirty="0"/>
              <a:t>Three items have been added.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1716E6B-19FC-9EE6-AEEE-A6C1F0F0BBD9}"/>
              </a:ext>
            </a:extLst>
          </p:cNvPr>
          <p:cNvSpPr txBox="1"/>
          <p:nvPr/>
        </p:nvSpPr>
        <p:spPr>
          <a:xfrm>
            <a:off x="7476638" y="4416935"/>
            <a:ext cx="1598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Two items have been added.</a:t>
            </a:r>
            <a:endParaRPr lang="en-NL" sz="9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F2D0077-8105-5202-973F-D53447614880}"/>
              </a:ext>
            </a:extLst>
          </p:cNvPr>
          <p:cNvSpPr txBox="1"/>
          <p:nvPr/>
        </p:nvSpPr>
        <p:spPr>
          <a:xfrm>
            <a:off x="8411794" y="4628866"/>
            <a:ext cx="16754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Three items have been added.</a:t>
            </a:r>
            <a:endParaRPr lang="en-NL" sz="9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7C31306-AFD9-9E29-4058-6EEA55CEF49C}"/>
              </a:ext>
            </a:extLst>
          </p:cNvPr>
          <p:cNvSpPr txBox="1"/>
          <p:nvPr/>
        </p:nvSpPr>
        <p:spPr>
          <a:xfrm>
            <a:off x="9339606" y="151023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/>
              <a:t>9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7AF5089-C7DC-96AA-E856-DBCB3720C0F0}"/>
              </a:ext>
            </a:extLst>
          </p:cNvPr>
          <p:cNvSpPr txBox="1"/>
          <p:nvPr/>
        </p:nvSpPr>
        <p:spPr>
          <a:xfrm>
            <a:off x="480791" y="1968258"/>
            <a:ext cx="17395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sz="900" dirty="0"/>
              <a:t>Pilot data set 1:</a:t>
            </a:r>
          </a:p>
          <a:p>
            <a:r>
              <a:rPr lang="en-NL" sz="900" dirty="0"/>
              <a:t>University Hospital, n=1; Rehabilitation Center, n=1;  nurses, n=34.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081ACCD-6BE9-00BF-8680-42B8782D845D}"/>
              </a:ext>
            </a:extLst>
          </p:cNvPr>
          <p:cNvSpPr txBox="1"/>
          <p:nvPr/>
        </p:nvSpPr>
        <p:spPr>
          <a:xfrm>
            <a:off x="2168878" y="1949491"/>
            <a:ext cx="128478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sz="900" dirty="0"/>
              <a:t>Data set 2: Hospitals, n=1; nurses, </a:t>
            </a:r>
            <a:r>
              <a:rPr lang="en-GB" sz="900" dirty="0"/>
              <a:t>n=278.</a:t>
            </a:r>
            <a:endParaRPr lang="en-NL" sz="900" dirty="0"/>
          </a:p>
          <a:p>
            <a:endParaRPr lang="en-NL" sz="900" dirty="0">
              <a:highlight>
                <a:srgbClr val="FFFF00"/>
              </a:highlight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472393E-8F34-BA73-38CF-6F9402E64DB9}"/>
              </a:ext>
            </a:extLst>
          </p:cNvPr>
          <p:cNvSpPr txBox="1"/>
          <p:nvPr/>
        </p:nvSpPr>
        <p:spPr>
          <a:xfrm>
            <a:off x="8308727" y="1960781"/>
            <a:ext cx="120486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Data set 5: Hospitals, n=3; nurses,  n=198.</a:t>
            </a:r>
            <a:endParaRPr lang="en-NL" sz="9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5EF2CE7-CF58-8C26-2ACC-75D1CE01E145}"/>
              </a:ext>
            </a:extLst>
          </p:cNvPr>
          <p:cNvSpPr txBox="1"/>
          <p:nvPr/>
        </p:nvSpPr>
        <p:spPr>
          <a:xfrm>
            <a:off x="10476176" y="1922155"/>
            <a:ext cx="15384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sz="900" dirty="0"/>
              <a:t>Data set </a:t>
            </a:r>
            <a:r>
              <a:rPr lang="en-GB" sz="900" dirty="0"/>
              <a:t>7: Hospitals, n = 22, and Rehabilitation </a:t>
            </a:r>
            <a:r>
              <a:rPr lang="en-GB" sz="900" dirty="0" err="1"/>
              <a:t>Centers</a:t>
            </a:r>
            <a:r>
              <a:rPr lang="en-GB" sz="900" dirty="0"/>
              <a:t>, n=2; </a:t>
            </a:r>
            <a:r>
              <a:rPr lang="en-NL" sz="900" dirty="0"/>
              <a:t> nurses, n=5,411. 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007CBBD-06C6-AD76-D638-16BE5C3C02AB}"/>
              </a:ext>
            </a:extLst>
          </p:cNvPr>
          <p:cNvSpPr txBox="1"/>
          <p:nvPr/>
        </p:nvSpPr>
        <p:spPr>
          <a:xfrm>
            <a:off x="5244516" y="1949604"/>
            <a:ext cx="1733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Data Set 4: Hospitals, n=2; nurses, n=205.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5BC36D5-01BE-1337-B60D-D4B609B84732}"/>
              </a:ext>
            </a:extLst>
          </p:cNvPr>
          <p:cNvSpPr txBox="1"/>
          <p:nvPr/>
        </p:nvSpPr>
        <p:spPr>
          <a:xfrm>
            <a:off x="3342105" y="1947723"/>
            <a:ext cx="151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sz="900" dirty="0"/>
              <a:t>Data set 3: Hospitals, n=1: </a:t>
            </a:r>
          </a:p>
          <a:p>
            <a:r>
              <a:rPr lang="en-GB" sz="900" dirty="0"/>
              <a:t>N</a:t>
            </a:r>
            <a:r>
              <a:rPr lang="en-NL" sz="900" dirty="0"/>
              <a:t>urses,  n=52 nurses.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31A3E7E0-F6BE-5E66-C8E7-0B13DBBD2B40}"/>
              </a:ext>
            </a:extLst>
          </p:cNvPr>
          <p:cNvCxnSpPr>
            <a:cxnSpLocks/>
          </p:cNvCxnSpPr>
          <p:nvPr/>
        </p:nvCxnSpPr>
        <p:spPr>
          <a:xfrm flipV="1">
            <a:off x="573502" y="2679634"/>
            <a:ext cx="0" cy="5339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97F81ED-8286-DB2C-7C1C-6A7B417EBF47}"/>
              </a:ext>
            </a:extLst>
          </p:cNvPr>
          <p:cNvSpPr txBox="1"/>
          <p:nvPr/>
        </p:nvSpPr>
        <p:spPr>
          <a:xfrm>
            <a:off x="478473" y="3336267"/>
            <a:ext cx="32720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2013 – 2014, 9 months, </a:t>
            </a:r>
          </a:p>
          <a:p>
            <a:r>
              <a:rPr lang="en-GB" sz="900" dirty="0"/>
              <a:t>from version 0.1 to 1.0:</a:t>
            </a:r>
          </a:p>
          <a:p>
            <a:r>
              <a:rPr lang="en-GB" sz="900" dirty="0"/>
              <a:t>Stage 1: Domain model</a:t>
            </a:r>
          </a:p>
          <a:p>
            <a:r>
              <a:rPr lang="en-GB" sz="900" dirty="0"/>
              <a:t>Stage 2: Task model</a:t>
            </a:r>
          </a:p>
          <a:p>
            <a:r>
              <a:rPr lang="en-GB" sz="900" dirty="0"/>
              <a:t>Stage 3: Presentation model</a:t>
            </a:r>
          </a:p>
          <a:p>
            <a:r>
              <a:rPr lang="en-GB" sz="900" dirty="0"/>
              <a:t>Stage 4: Evidence model</a:t>
            </a:r>
            <a:endParaRPr lang="en-NL" sz="9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00288A-FFA1-F2B5-85DF-2A2192A8C24F}"/>
              </a:ext>
            </a:extLst>
          </p:cNvPr>
          <p:cNvSpPr txBox="1"/>
          <p:nvPr/>
        </p:nvSpPr>
        <p:spPr>
          <a:xfrm>
            <a:off x="2177823" y="4129122"/>
            <a:ext cx="1587294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2015, version 2.0:</a:t>
            </a:r>
          </a:p>
          <a:p>
            <a:r>
              <a:rPr lang="en-GB" sz="900" dirty="0"/>
              <a:t>Stage 1: Domain model</a:t>
            </a:r>
          </a:p>
          <a:p>
            <a:r>
              <a:rPr lang="en-GB" sz="900" dirty="0"/>
              <a:t>Stage 2: Task model</a:t>
            </a:r>
          </a:p>
          <a:p>
            <a:r>
              <a:rPr lang="en-GB" sz="900" dirty="0"/>
              <a:t>Stage 3: Presentation model</a:t>
            </a:r>
          </a:p>
          <a:p>
            <a:r>
              <a:rPr lang="en-GB" sz="900" dirty="0"/>
              <a:t>Stage 4: Evidence model</a:t>
            </a:r>
            <a:endParaRPr lang="en-NL" sz="900" dirty="0"/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1991A7DD-4DCB-0CED-1543-6A42944035BC}"/>
              </a:ext>
            </a:extLst>
          </p:cNvPr>
          <p:cNvCxnSpPr>
            <a:cxnSpLocks/>
          </p:cNvCxnSpPr>
          <p:nvPr/>
        </p:nvCxnSpPr>
        <p:spPr>
          <a:xfrm>
            <a:off x="4187527" y="705570"/>
            <a:ext cx="5993208" cy="15221"/>
          </a:xfrm>
          <a:prstGeom prst="line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345B6799-906C-5C98-76C5-45BA9CB91AB9}"/>
              </a:ext>
            </a:extLst>
          </p:cNvPr>
          <p:cNvSpPr txBox="1"/>
          <p:nvPr/>
        </p:nvSpPr>
        <p:spPr>
          <a:xfrm>
            <a:off x="10368569" y="483915"/>
            <a:ext cx="1388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016 - 2023</a:t>
            </a:r>
            <a:endParaRPr lang="en-NL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3B338E6-7737-7776-E29F-6A7DC40E5FB1}"/>
              </a:ext>
            </a:extLst>
          </p:cNvPr>
          <p:cNvSpPr txBox="1"/>
          <p:nvPr/>
        </p:nvSpPr>
        <p:spPr>
          <a:xfrm>
            <a:off x="9354674" y="1943665"/>
            <a:ext cx="122107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Data Set 6: Hospitals, n=3; nurses, n=113.</a:t>
            </a:r>
            <a:endParaRPr lang="en-NL" sz="9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8552BD43-B1DE-DC3E-E8E5-C0E1AFDB9C27}"/>
              </a:ext>
            </a:extLst>
          </p:cNvPr>
          <p:cNvSpPr txBox="1"/>
          <p:nvPr/>
        </p:nvSpPr>
        <p:spPr>
          <a:xfrm>
            <a:off x="3350334" y="4941004"/>
            <a:ext cx="272864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2016, from version 3.0 to 3.6:</a:t>
            </a:r>
          </a:p>
          <a:p>
            <a:r>
              <a:rPr lang="en-GB" sz="900" dirty="0"/>
              <a:t>Stage 1: Domain model</a:t>
            </a:r>
          </a:p>
          <a:p>
            <a:r>
              <a:rPr lang="en-GB" sz="900" dirty="0"/>
              <a:t>Stage 2: Task model</a:t>
            </a:r>
          </a:p>
          <a:p>
            <a:r>
              <a:rPr lang="en-GB" sz="900" dirty="0"/>
              <a:t>Stage 3: Presentation model</a:t>
            </a:r>
          </a:p>
          <a:p>
            <a:r>
              <a:rPr lang="en-GB" sz="900" dirty="0"/>
              <a:t>Stage 4: Evidence model</a:t>
            </a:r>
            <a:endParaRPr lang="en-NL" sz="9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E4A4616-4707-E89B-200E-ABF4D311C439}"/>
              </a:ext>
            </a:extLst>
          </p:cNvPr>
          <p:cNvSpPr txBox="1"/>
          <p:nvPr/>
        </p:nvSpPr>
        <p:spPr>
          <a:xfrm>
            <a:off x="4083063" y="265416"/>
            <a:ext cx="627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sz="1600" dirty="0"/>
              <a:t>Timeline Evidence-Centered Design iterative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 process </a:t>
            </a:r>
            <a:r>
              <a:rPr lang="en-NL" sz="1600" dirty="0"/>
              <a:t>FA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A95C59-1BA5-D138-B702-09013174402D}"/>
              </a:ext>
            </a:extLst>
          </p:cNvPr>
          <p:cNvSpPr txBox="1"/>
          <p:nvPr/>
        </p:nvSpPr>
        <p:spPr>
          <a:xfrm>
            <a:off x="487441" y="6528742"/>
            <a:ext cx="103281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urses’ Professional Performance: The Development and Evaluation of a Formative Workplace-Based Self-Assessment Instrument, IJNSA-D-25-00609R1. ORCID-ID 0009-0007-1690-0504.</a:t>
            </a:r>
            <a:endParaRPr lang="en-NL" sz="900" dirty="0"/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AB979A04-CBC9-F3EE-BA35-C16635570382}"/>
              </a:ext>
            </a:extLst>
          </p:cNvPr>
          <p:cNvCxnSpPr>
            <a:cxnSpLocks/>
          </p:cNvCxnSpPr>
          <p:nvPr/>
        </p:nvCxnSpPr>
        <p:spPr>
          <a:xfrm flipV="1">
            <a:off x="2308330" y="3473262"/>
            <a:ext cx="0" cy="5339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7360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302</TotalTime>
  <Words>498</Words>
  <Application>Microsoft Macintosh PowerPoint</Application>
  <PresentationFormat>Widescreen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rmative Assessment for Nurses development timeline</dc:title>
  <dc:subject/>
  <dc:creator>FMD (Freda) Vasse</dc:creator>
  <cp:keywords/>
  <dc:description/>
  <cp:lastModifiedBy>Freda Vasse</cp:lastModifiedBy>
  <cp:revision>63</cp:revision>
  <dcterms:created xsi:type="dcterms:W3CDTF">2025-12-15T10:48:05Z</dcterms:created>
  <dcterms:modified xsi:type="dcterms:W3CDTF">2026-04-03T06:09:51Z</dcterms:modified>
  <cp:category/>
</cp:coreProperties>
</file>